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5" d="100"/>
          <a:sy n="65" d="100"/>
        </p:scale>
        <p:origin x="145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89AD0-AF77-4596-9D5D-6B9881E82156}" type="datetimeFigureOut">
              <a:rPr lang="en-CA" smtClean="0"/>
              <a:t>2019-07-2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4C72B-5529-4D0E-AE0F-4D89280B8BF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672240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89AD0-AF77-4596-9D5D-6B9881E82156}" type="datetimeFigureOut">
              <a:rPr lang="en-CA" smtClean="0"/>
              <a:t>2019-07-2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4C72B-5529-4D0E-AE0F-4D89280B8BF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830378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89AD0-AF77-4596-9D5D-6B9881E82156}" type="datetimeFigureOut">
              <a:rPr lang="en-CA" smtClean="0"/>
              <a:t>2019-07-2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4C72B-5529-4D0E-AE0F-4D89280B8BF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065416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89AD0-AF77-4596-9D5D-6B9881E82156}" type="datetimeFigureOut">
              <a:rPr lang="en-CA" smtClean="0"/>
              <a:t>2019-07-2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4C72B-5529-4D0E-AE0F-4D89280B8BF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742246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89AD0-AF77-4596-9D5D-6B9881E82156}" type="datetimeFigureOut">
              <a:rPr lang="en-CA" smtClean="0"/>
              <a:t>2019-07-2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4C72B-5529-4D0E-AE0F-4D89280B8BF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647465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89AD0-AF77-4596-9D5D-6B9881E82156}" type="datetimeFigureOut">
              <a:rPr lang="en-CA" smtClean="0"/>
              <a:t>2019-07-2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4C72B-5529-4D0E-AE0F-4D89280B8BF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712810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89AD0-AF77-4596-9D5D-6B9881E82156}" type="datetimeFigureOut">
              <a:rPr lang="en-CA" smtClean="0"/>
              <a:t>2019-07-26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4C72B-5529-4D0E-AE0F-4D89280B8BF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072337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89AD0-AF77-4596-9D5D-6B9881E82156}" type="datetimeFigureOut">
              <a:rPr lang="en-CA" smtClean="0"/>
              <a:t>2019-07-26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4C72B-5529-4D0E-AE0F-4D89280B8BF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016560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89AD0-AF77-4596-9D5D-6B9881E82156}" type="datetimeFigureOut">
              <a:rPr lang="en-CA" smtClean="0"/>
              <a:t>2019-07-26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4C72B-5529-4D0E-AE0F-4D89280B8BF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806223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89AD0-AF77-4596-9D5D-6B9881E82156}" type="datetimeFigureOut">
              <a:rPr lang="en-CA" smtClean="0"/>
              <a:t>2019-07-2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4C72B-5529-4D0E-AE0F-4D89280B8BF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897494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89AD0-AF77-4596-9D5D-6B9881E82156}" type="datetimeFigureOut">
              <a:rPr lang="en-CA" smtClean="0"/>
              <a:t>2019-07-2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4C72B-5529-4D0E-AE0F-4D89280B8BF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840829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689AD0-AF77-4596-9D5D-6B9881E82156}" type="datetimeFigureOut">
              <a:rPr lang="en-CA" smtClean="0"/>
              <a:t>2019-07-2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74C72B-5529-4D0E-AE0F-4D89280B8BF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8285257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7"/>
          <p:cNvPicPr>
            <a:picLocks noGrp="1" noChangeAspect="1"/>
          </p:cNvPicPr>
          <p:nvPr>
            <p:ph sz="half"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4511" y="309715"/>
            <a:ext cx="6827521" cy="512064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32735" y="5559439"/>
            <a:ext cx="9143999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.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s between LAB families and the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steurellaceae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amily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nasopharyngeal microbiota of cattle (n = 13) by sampling time. The Spearman’s correlation coefficient (blue line bar) for the correlations of each LAB family with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steurellaceae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s calculated based on the relative abundance of these families observed on each sampling time using Spearman’s rank correlation method. The dotted lines indicate where r (actually Pearson’s correlation) would be statistically significant with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05.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se are calculated based on </a:t>
            </a:r>
            <a:r>
              <a:rPr lang="en-CA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lues of approximately 1.96 and </a:t>
            </a:r>
            <a:r>
              <a:rPr lang="en-CA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13. Therefore the lines are located at +/- 0.51.</a:t>
            </a:r>
          </a:p>
          <a:p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9314803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</TotalTime>
  <Words>111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Needle plot of Spearman correlations</dc:title>
  <dc:creator>Schwinghamer, Timothy</dc:creator>
  <cp:lastModifiedBy>Saimaiti, Amaiti</cp:lastModifiedBy>
  <cp:revision>4</cp:revision>
  <dcterms:created xsi:type="dcterms:W3CDTF">2019-05-03T19:29:08Z</dcterms:created>
  <dcterms:modified xsi:type="dcterms:W3CDTF">2019-07-27T02:05:31Z</dcterms:modified>
</cp:coreProperties>
</file>